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893"/>
    <a:srgbClr val="942093"/>
    <a:srgbClr val="9437FF"/>
    <a:srgbClr val="FF9300"/>
    <a:srgbClr val="929292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04"/>
    <p:restoredTop sz="96310"/>
  </p:normalViewPr>
  <p:slideViewPr>
    <p:cSldViewPr snapToGrid="0">
      <p:cViewPr varScale="1">
        <p:scale>
          <a:sx n="103" d="100"/>
          <a:sy n="103" d="100"/>
        </p:scale>
        <p:origin x="48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6A4D8E-4468-8940-8495-075939C632A2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EE1239-6483-EE4F-A3E6-E515071B15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59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07075A-7CC3-C348-8DCC-6C7A958E476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9407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02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356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75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52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1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911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17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4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312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49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78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EEA8B2D-1349-B946-1FE6-16095F62BF72}"/>
              </a:ext>
            </a:extLst>
          </p:cNvPr>
          <p:cNvSpPr txBox="1"/>
          <p:nvPr/>
        </p:nvSpPr>
        <p:spPr>
          <a:xfrm>
            <a:off x="0" y="-21905"/>
            <a:ext cx="643364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 S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CAD9874-1917-3730-2C17-8CFBDEF5E90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213" t="253" r="213" b="6623"/>
          <a:stretch/>
        </p:blipFill>
        <p:spPr>
          <a:xfrm>
            <a:off x="499231" y="699439"/>
            <a:ext cx="935027" cy="103327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BD2BB87-2A14-178D-ECAB-42005F7C4AA5}"/>
              </a:ext>
            </a:extLst>
          </p:cNvPr>
          <p:cNvSpPr txBox="1"/>
          <p:nvPr/>
        </p:nvSpPr>
        <p:spPr>
          <a:xfrm>
            <a:off x="759938" y="473393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P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E40F0C4-BA19-B894-844A-6EA75A4C97EC}"/>
              </a:ext>
            </a:extLst>
          </p:cNvPr>
          <p:cNvSpPr txBox="1"/>
          <p:nvPr/>
        </p:nvSpPr>
        <p:spPr>
          <a:xfrm>
            <a:off x="700902" y="599345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100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5F2CC39-DC74-1972-6B9E-CA7FA7137D6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750" t="50000" r="21039" b="26191"/>
          <a:stretch/>
        </p:blipFill>
        <p:spPr>
          <a:xfrm rot="5400000" flipV="1">
            <a:off x="3891186" y="1107053"/>
            <a:ext cx="522006" cy="27389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0300248-D558-E58B-6828-363EC02225ED}"/>
              </a:ext>
            </a:extLst>
          </p:cNvPr>
          <p:cNvSpPr txBox="1"/>
          <p:nvPr/>
        </p:nvSpPr>
        <p:spPr>
          <a:xfrm>
            <a:off x="4250397" y="983190"/>
            <a:ext cx="6783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sz="9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low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C6176CB-9820-2497-3BCA-DA965D9AC0BB}"/>
              </a:ext>
            </a:extLst>
          </p:cNvPr>
          <p:cNvSpPr txBox="1"/>
          <p:nvPr/>
        </p:nvSpPr>
        <p:spPr>
          <a:xfrm>
            <a:off x="4250397" y="1241310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sz="9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high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2E29FF5-5E71-C4D6-665D-B931FACBDA02}"/>
              </a:ext>
            </a:extLst>
          </p:cNvPr>
          <p:cNvSpPr txBox="1"/>
          <p:nvPr/>
        </p:nvSpPr>
        <p:spPr>
          <a:xfrm>
            <a:off x="3916973" y="752358"/>
            <a:ext cx="9733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M response: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0CAB86B-5BF8-FAC8-0619-5387E57CD4F4}"/>
              </a:ext>
            </a:extLst>
          </p:cNvPr>
          <p:cNvSpPr txBox="1"/>
          <p:nvPr/>
        </p:nvSpPr>
        <p:spPr>
          <a:xfrm rot="16200000">
            <a:off x="-94996" y="1079928"/>
            <a:ext cx="10807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FU per 3e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cells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A006AEBD-F634-CCF4-8104-BA7D084B1AC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88" t="442" r="-188" b="7950"/>
          <a:stretch/>
        </p:blipFill>
        <p:spPr>
          <a:xfrm>
            <a:off x="1595590" y="656651"/>
            <a:ext cx="1015089" cy="106103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77C790D-D6AF-D85A-C572-67233EE317A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97" t="1514" r="-197" b="7557"/>
          <a:stretch/>
        </p:blipFill>
        <p:spPr>
          <a:xfrm>
            <a:off x="2429781" y="705205"/>
            <a:ext cx="1056277" cy="1017633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8CAD8B6B-ACFD-10C6-97B0-39C9CE8A9D94}"/>
              </a:ext>
            </a:extLst>
          </p:cNvPr>
          <p:cNvSpPr txBox="1"/>
          <p:nvPr/>
        </p:nvSpPr>
        <p:spPr>
          <a:xfrm>
            <a:off x="1762477" y="473393"/>
            <a:ext cx="8130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2024 IgG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ED900C2-57CE-1213-75D1-F36DE0B59076}"/>
              </a:ext>
            </a:extLst>
          </p:cNvPr>
          <p:cNvSpPr txBox="1"/>
          <p:nvPr/>
        </p:nvSpPr>
        <p:spPr>
          <a:xfrm>
            <a:off x="2535029" y="473393"/>
            <a:ext cx="1136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2024 IgG + IgM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B001B11-1897-6CF1-3A18-B3C6A0E2A680}"/>
              </a:ext>
            </a:extLst>
          </p:cNvPr>
          <p:cNvSpPr txBox="1"/>
          <p:nvPr/>
        </p:nvSpPr>
        <p:spPr>
          <a:xfrm>
            <a:off x="1888312" y="599345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693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EF91496-AEA4-1832-BF59-A1CBEDA31900}"/>
              </a:ext>
            </a:extLst>
          </p:cNvPr>
          <p:cNvSpPr txBox="1"/>
          <p:nvPr/>
        </p:nvSpPr>
        <p:spPr>
          <a:xfrm>
            <a:off x="2729438" y="599345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458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8031F8A-6A21-C2B6-FBC5-4F2D6554B198}"/>
              </a:ext>
            </a:extLst>
          </p:cNvPr>
          <p:cNvSpPr txBox="1"/>
          <p:nvPr/>
        </p:nvSpPr>
        <p:spPr>
          <a:xfrm rot="16200000">
            <a:off x="1070038" y="1045957"/>
            <a:ext cx="8579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tibody titer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BDFADDC-2D36-97E0-969A-A8A373CC6D12}"/>
              </a:ext>
            </a:extLst>
          </p:cNvPr>
          <p:cNvSpPr txBox="1"/>
          <p:nvPr/>
        </p:nvSpPr>
        <p:spPr>
          <a:xfrm>
            <a:off x="121483" y="338767"/>
            <a:ext cx="2920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9B13F0E-8107-87C5-BE85-9DEA859BDF32}"/>
              </a:ext>
            </a:extLst>
          </p:cNvPr>
          <p:cNvSpPr txBox="1"/>
          <p:nvPr/>
        </p:nvSpPr>
        <p:spPr>
          <a:xfrm>
            <a:off x="1266213" y="338767"/>
            <a:ext cx="29206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/>
              <a:t>B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238409C8-0EB3-5FC7-9C6F-EA4D9120A090}"/>
              </a:ext>
            </a:extLst>
          </p:cNvPr>
          <p:cNvSpPr txBox="1"/>
          <p:nvPr/>
        </p:nvSpPr>
        <p:spPr>
          <a:xfrm>
            <a:off x="121483" y="1916082"/>
            <a:ext cx="236262" cy="305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C</a:t>
            </a:r>
          </a:p>
        </p:txBody>
      </p:sp>
      <p:pic>
        <p:nvPicPr>
          <p:cNvPr id="121" name="Picture 120">
            <a:extLst>
              <a:ext uri="{FF2B5EF4-FFF2-40B4-BE49-F238E27FC236}">
                <a16:creationId xmlns:a16="http://schemas.microsoft.com/office/drawing/2014/main" id="{BB8B13AE-1EE6-EB77-5E7E-E2520F1AAFD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6526"/>
          <a:stretch/>
        </p:blipFill>
        <p:spPr>
          <a:xfrm>
            <a:off x="474043" y="2113551"/>
            <a:ext cx="1015089" cy="1125955"/>
          </a:xfrm>
          <a:prstGeom prst="rect">
            <a:avLst/>
          </a:prstGeom>
        </p:spPr>
      </p:pic>
      <p:pic>
        <p:nvPicPr>
          <p:cNvPr id="123" name="Picture 122">
            <a:extLst>
              <a:ext uri="{FF2B5EF4-FFF2-40B4-BE49-F238E27FC236}">
                <a16:creationId xmlns:a16="http://schemas.microsoft.com/office/drawing/2014/main" id="{EB1D6582-B003-C785-DCD5-1A1758F9354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6409"/>
          <a:stretch/>
        </p:blipFill>
        <p:spPr>
          <a:xfrm>
            <a:off x="1372755" y="2109860"/>
            <a:ext cx="1017141" cy="1129646"/>
          </a:xfrm>
          <a:prstGeom prst="rect">
            <a:avLst/>
          </a:prstGeom>
        </p:spPr>
      </p:pic>
      <p:pic>
        <p:nvPicPr>
          <p:cNvPr id="125" name="Picture 124">
            <a:extLst>
              <a:ext uri="{FF2B5EF4-FFF2-40B4-BE49-F238E27FC236}">
                <a16:creationId xmlns:a16="http://schemas.microsoft.com/office/drawing/2014/main" id="{3A1005E9-C527-3745-4692-50F049FEA45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6220"/>
          <a:stretch/>
        </p:blipFill>
        <p:spPr>
          <a:xfrm>
            <a:off x="3109692" y="2114964"/>
            <a:ext cx="1015089" cy="1129646"/>
          </a:xfrm>
          <a:prstGeom prst="rect">
            <a:avLst/>
          </a:prstGeom>
        </p:spPr>
      </p:pic>
      <p:pic>
        <p:nvPicPr>
          <p:cNvPr id="127" name="Picture 126">
            <a:extLst>
              <a:ext uri="{FF2B5EF4-FFF2-40B4-BE49-F238E27FC236}">
                <a16:creationId xmlns:a16="http://schemas.microsoft.com/office/drawing/2014/main" id="{CFE2294F-C71C-5989-0A4D-51FE6503F0B1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b="6409"/>
          <a:stretch/>
        </p:blipFill>
        <p:spPr>
          <a:xfrm>
            <a:off x="2265245" y="2109860"/>
            <a:ext cx="1017142" cy="1129646"/>
          </a:xfrm>
          <a:prstGeom prst="rect">
            <a:avLst/>
          </a:prstGeom>
        </p:spPr>
      </p:pic>
      <p:sp>
        <p:nvSpPr>
          <p:cNvPr id="128" name="TextBox 127">
            <a:extLst>
              <a:ext uri="{FF2B5EF4-FFF2-40B4-BE49-F238E27FC236}">
                <a16:creationId xmlns:a16="http://schemas.microsoft.com/office/drawing/2014/main" id="{F064CDAC-30B2-DB32-1809-22AED337D0B2}"/>
              </a:ext>
            </a:extLst>
          </p:cNvPr>
          <p:cNvSpPr txBox="1"/>
          <p:nvPr/>
        </p:nvSpPr>
        <p:spPr>
          <a:xfrm>
            <a:off x="700901" y="2083918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102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851C0641-B36C-44DE-16E7-E00EE2598438}"/>
              </a:ext>
            </a:extLst>
          </p:cNvPr>
          <p:cNvSpPr txBox="1"/>
          <p:nvPr/>
        </p:nvSpPr>
        <p:spPr>
          <a:xfrm>
            <a:off x="1586993" y="2083918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427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7D3A2995-0FAF-ED75-B5AA-1DF4C0D2CF2C}"/>
              </a:ext>
            </a:extLst>
          </p:cNvPr>
          <p:cNvSpPr txBox="1"/>
          <p:nvPr/>
        </p:nvSpPr>
        <p:spPr>
          <a:xfrm>
            <a:off x="3360987" y="2083918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409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C1B8CC1F-CAE3-7B17-4C69-DEE0225998BC}"/>
              </a:ext>
            </a:extLst>
          </p:cNvPr>
          <p:cNvSpPr txBox="1"/>
          <p:nvPr/>
        </p:nvSpPr>
        <p:spPr>
          <a:xfrm>
            <a:off x="2493130" y="2083918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735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E76410D9-B9F0-AB60-7CFB-0AAB73039B74}"/>
              </a:ext>
            </a:extLst>
          </p:cNvPr>
          <p:cNvSpPr txBox="1"/>
          <p:nvPr/>
        </p:nvSpPr>
        <p:spPr>
          <a:xfrm>
            <a:off x="606421" y="1924914"/>
            <a:ext cx="7809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D4 T cells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FFD17467-26A8-9A08-DC2F-A2FE352197B2}"/>
              </a:ext>
            </a:extLst>
          </p:cNvPr>
          <p:cNvSpPr txBox="1"/>
          <p:nvPr/>
        </p:nvSpPr>
        <p:spPr>
          <a:xfrm>
            <a:off x="1556162" y="1924914"/>
            <a:ext cx="7809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D8 T cells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0EB6749A-7113-9228-6507-64F020A749DB}"/>
              </a:ext>
            </a:extLst>
          </p:cNvPr>
          <p:cNvSpPr txBox="1"/>
          <p:nvPr/>
        </p:nvSpPr>
        <p:spPr>
          <a:xfrm>
            <a:off x="2499485" y="1924914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052361BF-A01C-CCFC-445A-40AB4851918D}"/>
              </a:ext>
            </a:extLst>
          </p:cNvPr>
          <p:cNvSpPr txBox="1"/>
          <p:nvPr/>
        </p:nvSpPr>
        <p:spPr>
          <a:xfrm>
            <a:off x="3239310" y="1924914"/>
            <a:ext cx="7425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onocytes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48B198A3-1960-04BA-3485-07BAA5FC25EE}"/>
              </a:ext>
            </a:extLst>
          </p:cNvPr>
          <p:cNvSpPr txBox="1"/>
          <p:nvPr/>
        </p:nvSpPr>
        <p:spPr>
          <a:xfrm>
            <a:off x="4250397" y="2426038"/>
            <a:ext cx="6783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sz="9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low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BAC45052-A300-4FC9-4677-50F6CC90DEE4}"/>
              </a:ext>
            </a:extLst>
          </p:cNvPr>
          <p:cNvSpPr txBox="1"/>
          <p:nvPr/>
        </p:nvSpPr>
        <p:spPr>
          <a:xfrm>
            <a:off x="4250397" y="2684158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sz="9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high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B4A0B3E2-A505-04DE-EEED-AD4104E83601}"/>
              </a:ext>
            </a:extLst>
          </p:cNvPr>
          <p:cNvSpPr txBox="1"/>
          <p:nvPr/>
        </p:nvSpPr>
        <p:spPr>
          <a:xfrm>
            <a:off x="3916973" y="2195206"/>
            <a:ext cx="9733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M response: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pic>
        <p:nvPicPr>
          <p:cNvPr id="145" name="Picture 144">
            <a:extLst>
              <a:ext uri="{FF2B5EF4-FFF2-40B4-BE49-F238E27FC236}">
                <a16:creationId xmlns:a16="http://schemas.microsoft.com/office/drawing/2014/main" id="{6D40087E-B63D-9D4B-41CA-5629C217608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618345" y="3162904"/>
            <a:ext cx="1752005" cy="1624917"/>
          </a:xfrm>
          <a:prstGeom prst="rect">
            <a:avLst/>
          </a:prstGeom>
        </p:spPr>
      </p:pic>
      <p:sp>
        <p:nvSpPr>
          <p:cNvPr id="147" name="TextBox 146">
            <a:extLst>
              <a:ext uri="{FF2B5EF4-FFF2-40B4-BE49-F238E27FC236}">
                <a16:creationId xmlns:a16="http://schemas.microsoft.com/office/drawing/2014/main" id="{B0C2D2D8-825E-64D4-966E-21B9F8B510B8}"/>
              </a:ext>
            </a:extLst>
          </p:cNvPr>
          <p:cNvSpPr txBox="1"/>
          <p:nvPr/>
        </p:nvSpPr>
        <p:spPr>
          <a:xfrm>
            <a:off x="5081949" y="4736209"/>
            <a:ext cx="13933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azard ratio -/+ 95% CI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539427E4-4AAE-DD08-055D-D39EAB4F3661}"/>
              </a:ext>
            </a:extLst>
          </p:cNvPr>
          <p:cNvSpPr txBox="1"/>
          <p:nvPr/>
        </p:nvSpPr>
        <p:spPr>
          <a:xfrm>
            <a:off x="6037563" y="3297157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16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C9F7B4DF-E6FD-E441-D9B3-BF9261AE7F31}"/>
              </a:ext>
            </a:extLst>
          </p:cNvPr>
          <p:cNvSpPr txBox="1"/>
          <p:nvPr/>
        </p:nvSpPr>
        <p:spPr>
          <a:xfrm>
            <a:off x="6037563" y="3543705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74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A74B167F-DEF2-8852-32F5-F698009C8E32}"/>
              </a:ext>
            </a:extLst>
          </p:cNvPr>
          <p:cNvSpPr txBox="1"/>
          <p:nvPr/>
        </p:nvSpPr>
        <p:spPr>
          <a:xfrm>
            <a:off x="6037563" y="3798198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35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EDE83559-F5B2-46D7-E366-427C1BD2C256}"/>
              </a:ext>
            </a:extLst>
          </p:cNvPr>
          <p:cNvSpPr txBox="1"/>
          <p:nvPr/>
        </p:nvSpPr>
        <p:spPr>
          <a:xfrm>
            <a:off x="6037563" y="405452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74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9091E8B2-0D3E-62BC-47DB-494C833A4CF4}"/>
              </a:ext>
            </a:extLst>
          </p:cNvPr>
          <p:cNvSpPr txBox="1"/>
          <p:nvPr/>
        </p:nvSpPr>
        <p:spPr>
          <a:xfrm>
            <a:off x="6037563" y="4295824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=0.04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BC0A7182-C641-549A-5EE3-3D056EFB1216}"/>
              </a:ext>
            </a:extLst>
          </p:cNvPr>
          <p:cNvSpPr txBox="1"/>
          <p:nvPr/>
        </p:nvSpPr>
        <p:spPr>
          <a:xfrm rot="16200000">
            <a:off x="-36526" y="2540998"/>
            <a:ext cx="9156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% live singlets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348A7622-8C1F-3AE5-7CFD-3F36EEE93E4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6708" y="5044525"/>
            <a:ext cx="2578612" cy="145747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B80EB40-5A2E-549F-BE28-4B80614E9E0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301004" y="5007569"/>
            <a:ext cx="2426676" cy="1428043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5E6C855-A23F-69C9-67C2-33A170333776}"/>
              </a:ext>
            </a:extLst>
          </p:cNvPr>
          <p:cNvSpPr txBox="1"/>
          <p:nvPr/>
        </p:nvSpPr>
        <p:spPr>
          <a:xfrm>
            <a:off x="121483" y="3258419"/>
            <a:ext cx="236262" cy="305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4F46BCA-E6F2-280D-ACBD-41DB53E0A12F}"/>
              </a:ext>
            </a:extLst>
          </p:cNvPr>
          <p:cNvSpPr txBox="1"/>
          <p:nvPr/>
        </p:nvSpPr>
        <p:spPr>
          <a:xfrm>
            <a:off x="1382400" y="4975223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pearman R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3E3DFFE-2839-CAAF-F4FC-51AED29E7C40}"/>
              </a:ext>
            </a:extLst>
          </p:cNvPr>
          <p:cNvSpPr txBox="1"/>
          <p:nvPr/>
        </p:nvSpPr>
        <p:spPr>
          <a:xfrm>
            <a:off x="4122647" y="4935372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log(p-value)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408AD77-224F-E3B3-3447-82ED17D0B774}"/>
              </a:ext>
            </a:extLst>
          </p:cNvPr>
          <p:cNvSpPr txBox="1"/>
          <p:nvPr/>
        </p:nvSpPr>
        <p:spPr>
          <a:xfrm>
            <a:off x="4375772" y="3239506"/>
            <a:ext cx="236262" cy="305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E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8516C1C1-9C3F-3DF6-144A-1BF271A55A46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/>
          <a:stretch/>
        </p:blipFill>
        <p:spPr>
          <a:xfrm>
            <a:off x="475311" y="3560563"/>
            <a:ext cx="1043769" cy="123860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BDED0BC7-F9EE-4CED-2C55-8E2A00DA0BFA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/>
          <a:stretch/>
        </p:blipFill>
        <p:spPr>
          <a:xfrm>
            <a:off x="1389855" y="3530234"/>
            <a:ext cx="1059562" cy="1257348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73949EC7-A5D5-4C98-97A1-19254906F936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/>
          <a:stretch/>
        </p:blipFill>
        <p:spPr>
          <a:xfrm>
            <a:off x="2301784" y="3530234"/>
            <a:ext cx="1059562" cy="1257348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2A3041FC-0653-CFF0-AEDD-5827766A249E}"/>
              </a:ext>
            </a:extLst>
          </p:cNvPr>
          <p:cNvSpPr txBox="1"/>
          <p:nvPr/>
        </p:nvSpPr>
        <p:spPr>
          <a:xfrm>
            <a:off x="777456" y="3306875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HA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93EC1DD-FB0F-5570-C23B-E16CE22CD657}"/>
              </a:ext>
            </a:extLst>
          </p:cNvPr>
          <p:cNvSpPr txBox="1"/>
          <p:nvPr/>
        </p:nvSpPr>
        <p:spPr>
          <a:xfrm>
            <a:off x="1644622" y="3306875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Fluzone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AEE89B8-10EF-04A3-809D-659FA81A79A5}"/>
              </a:ext>
            </a:extLst>
          </p:cNvPr>
          <p:cNvSpPr txBox="1"/>
          <p:nvPr/>
        </p:nvSpPr>
        <p:spPr>
          <a:xfrm>
            <a:off x="2614394" y="3306875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EFT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E46B3F3-1FED-5ABB-5177-99E303C8C9D7}"/>
              </a:ext>
            </a:extLst>
          </p:cNvPr>
          <p:cNvSpPr txBox="1"/>
          <p:nvPr/>
        </p:nvSpPr>
        <p:spPr>
          <a:xfrm>
            <a:off x="692848" y="3460314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46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52020D3-B08E-5391-4459-BA1F53A4B6BE}"/>
              </a:ext>
            </a:extLst>
          </p:cNvPr>
          <p:cNvSpPr txBox="1"/>
          <p:nvPr/>
        </p:nvSpPr>
        <p:spPr>
          <a:xfrm>
            <a:off x="1634714" y="345447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15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99FECC1-84DB-6797-886E-2AEF7D96EB45}"/>
              </a:ext>
            </a:extLst>
          </p:cNvPr>
          <p:cNvSpPr txBox="1"/>
          <p:nvPr/>
        </p:nvSpPr>
        <p:spPr>
          <a:xfrm>
            <a:off x="2566983" y="3454471"/>
            <a:ext cx="5613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=0.089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ED44FAA-E746-D949-0BE4-16865E38218E}"/>
              </a:ext>
            </a:extLst>
          </p:cNvPr>
          <p:cNvSpPr txBox="1"/>
          <p:nvPr/>
        </p:nvSpPr>
        <p:spPr>
          <a:xfrm>
            <a:off x="3595079" y="3829860"/>
            <a:ext cx="6783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sz="9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low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FF08ADF-75FF-0948-010B-33248E091EC2}"/>
              </a:ext>
            </a:extLst>
          </p:cNvPr>
          <p:cNvSpPr txBox="1"/>
          <p:nvPr/>
        </p:nvSpPr>
        <p:spPr>
          <a:xfrm>
            <a:off x="3595079" y="4087980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lang="en-US" sz="900" dirty="0">
                <a:latin typeface="Symbol" pitchFamily="2" charset="2"/>
                <a:cs typeface="Arial" panose="020B0604020202020204" pitchFamily="34" charset="0"/>
              </a:rPr>
              <a:t>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high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DF0ADF3-0FF1-C63A-6BA1-57F845E69502}"/>
              </a:ext>
            </a:extLst>
          </p:cNvPr>
          <p:cNvSpPr txBox="1"/>
          <p:nvPr/>
        </p:nvSpPr>
        <p:spPr>
          <a:xfrm>
            <a:off x="3261655" y="3599028"/>
            <a:ext cx="9733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M response: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499471F-7295-C251-1681-07C87BCC3874}"/>
              </a:ext>
            </a:extLst>
          </p:cNvPr>
          <p:cNvSpPr txBox="1"/>
          <p:nvPr/>
        </p:nvSpPr>
        <p:spPr>
          <a:xfrm rot="16200000">
            <a:off x="-202437" y="3997064"/>
            <a:ext cx="12474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FU per 3e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/ CD4 T </a:t>
            </a:r>
            <a:endParaRPr lang="en-US" sz="900" dirty="0">
              <a:latin typeface="Symbol" pitchFamily="2" charset="2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2C5CE00-53F9-3373-632D-9A5B1A374FE9}"/>
              </a:ext>
            </a:extLst>
          </p:cNvPr>
          <p:cNvSpPr txBox="1"/>
          <p:nvPr/>
        </p:nvSpPr>
        <p:spPr>
          <a:xfrm>
            <a:off x="147297" y="4937760"/>
            <a:ext cx="236262" cy="305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9C6172B-24BE-BC44-9C34-A9DCB2C22A4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750" t="50000" r="21039" b="26191"/>
          <a:stretch/>
        </p:blipFill>
        <p:spPr>
          <a:xfrm rot="5400000" flipV="1">
            <a:off x="3918968" y="2549031"/>
            <a:ext cx="522006" cy="27389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385B9E6-542B-C71F-479A-15225B4685E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750" t="50000" r="21039" b="26191"/>
          <a:stretch/>
        </p:blipFill>
        <p:spPr>
          <a:xfrm rot="5400000" flipV="1">
            <a:off x="3266281" y="3964275"/>
            <a:ext cx="522006" cy="27389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4946CB1E-7CBF-3F9A-C91D-F6A75EFE24AB}"/>
              </a:ext>
            </a:extLst>
          </p:cNvPr>
          <p:cNvSpPr txBox="1"/>
          <p:nvPr/>
        </p:nvSpPr>
        <p:spPr>
          <a:xfrm>
            <a:off x="214721" y="6636783"/>
            <a:ext cx="6428557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 (related to Figure 3).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 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tended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ti-PAP and/or PA2024 (vaccine antigen) immunity measured by ELISpot (A, n=89) and ELISA (B, n=99) and stratified by median IFN-</a:t>
            </a:r>
            <a:r>
              <a:rPr lang="en-US" sz="1200" dirty="0">
                <a:solidFill>
                  <a:srgbClr val="212121"/>
                </a:solidFill>
                <a:effectLst/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duction after TLR1/2 stimulation (fold mock)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Flow cytometry analysis of KCI validation cohort PBMCs (n=28) for cell types tested in the PRIME cohort as shown in Figure 3B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ELISpot features from Fig 3B normalized by CD4 T cell proportions in blood (SFU/%CD4 T cells)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Cox proportional hazard model hazard ratios -/+ 95% confidence interval (CI) adjusting for cell type density (% of live singlet PBMCs) vs IFN-</a:t>
            </a:r>
            <a:r>
              <a:rPr lang="en-US" sz="1200" dirty="0">
                <a:solidFill>
                  <a:srgbClr val="212121"/>
                </a:solidFill>
                <a:effectLst/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duction after TLR1/2 stimulation in the PRIME study (n=106). 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Correlation (Spearman r, left) and corresponding -log(p-values) of TLR1/2 induced IFN-</a:t>
            </a:r>
            <a:r>
              <a:rPr lang="en-US" sz="1200" dirty="0">
                <a:solidFill>
                  <a:srgbClr val="212121"/>
                </a:solidFill>
                <a:effectLst/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ersus all other cytokines after each treatment. 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-D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Mean -/+ SEM is shown. PAM, PAM</a:t>
            </a:r>
            <a:r>
              <a:rPr lang="en-US" sz="1200" baseline="-250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K</a:t>
            </a:r>
            <a:r>
              <a:rPr lang="en-US" sz="1200" baseline="-250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4223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58</TotalTime>
  <Words>315</Words>
  <Application>Microsoft Macintosh PowerPoint</Application>
  <PresentationFormat>Letter Paper (8.5x11 in)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rown</dc:creator>
  <cp:lastModifiedBy>Michael Brown</cp:lastModifiedBy>
  <cp:revision>36</cp:revision>
  <dcterms:created xsi:type="dcterms:W3CDTF">2024-05-14T01:47:53Z</dcterms:created>
  <dcterms:modified xsi:type="dcterms:W3CDTF">2024-09-16T19:26:48Z</dcterms:modified>
</cp:coreProperties>
</file>